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74C0DD-1D30-46E1-B0B4-8957C878A93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183E28-C86E-4F6E-A540-4538D04F47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3689E3-CBC1-4635-982A-01046778DFC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D1C4AF-A71F-408A-BD94-5C91A804144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9A8FE1-9366-4324-823E-8817A6F549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51E221-A46D-4055-BA52-21A3E27463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BCD881-97E9-4F21-8578-81174B6FFF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E67A68-6AC0-492F-A7B2-2C2F01284E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520CC-B73B-478A-8629-6FEB6D3BE4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CE02F4-4E74-447B-B6D8-7AF547ADC0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538312-C182-4057-8751-0B312D586C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690147-ADF4-448F-B025-7A4D9F1D6E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6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6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6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79CF11-EA02-4F30-BA30-690818FCDB5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package" Target="../embeddings/oleObject3.xlsx"/><Relationship Id="rId6" Type="http://schemas.openxmlformats.org/officeDocument/2006/relationships/image" Target="../media/image3.wmf"/><Relationship Id="rId7" Type="http://schemas.openxmlformats.org/officeDocument/2006/relationships/package" Target="../embeddings/oleObject4.xlsx"/><Relationship Id="rId8" Type="http://schemas.openxmlformats.org/officeDocument/2006/relationships/image" Target="../media/image4.wmf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375000" y="162000"/>
            <a:ext cx="3057480" cy="2933640"/>
            <a:chOff x="3375000" y="162000"/>
            <a:chExt cx="3057480" cy="2933640"/>
          </a:xfrm>
        </p:grpSpPr>
        <p:graphicFrame>
          <p:nvGraphicFramePr>
            <p:cNvPr id="42" name=""/>
            <p:cNvGraphicFramePr/>
            <p:nvPr/>
          </p:nvGraphicFramePr>
          <p:xfrm>
            <a:off x="3375000" y="162000"/>
            <a:ext cx="3057480" cy="293364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375000" y="162000"/>
                      <a:ext cx="3057480" cy="29336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" name=""/>
            <p:cNvSpPr/>
            <p:nvPr/>
          </p:nvSpPr>
          <p:spPr>
            <a:xfrm>
              <a:off x="3662640" y="465120"/>
              <a:ext cx="30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(b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5" name=""/>
          <p:cNvGrpSpPr/>
          <p:nvPr/>
        </p:nvGrpSpPr>
        <p:grpSpPr>
          <a:xfrm>
            <a:off x="3519360" y="2959200"/>
            <a:ext cx="3048120" cy="2520720"/>
            <a:chOff x="3519360" y="2959200"/>
            <a:chExt cx="3048120" cy="2520720"/>
          </a:xfrm>
        </p:grpSpPr>
        <p:graphicFrame>
          <p:nvGraphicFramePr>
            <p:cNvPr id="46" name=""/>
            <p:cNvGraphicFramePr/>
            <p:nvPr/>
          </p:nvGraphicFramePr>
          <p:xfrm>
            <a:off x="3519360" y="3041640"/>
            <a:ext cx="3048120" cy="243828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47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3519360" y="3041640"/>
                      <a:ext cx="3048120" cy="24382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8" name=""/>
            <p:cNvSpPr/>
            <p:nvPr/>
          </p:nvSpPr>
          <p:spPr>
            <a:xfrm>
              <a:off x="3687840" y="2959200"/>
              <a:ext cx="30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(d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9" name=""/>
          <p:cNvGrpSpPr/>
          <p:nvPr/>
        </p:nvGrpSpPr>
        <p:grpSpPr>
          <a:xfrm>
            <a:off x="277920" y="431640"/>
            <a:ext cx="3152520" cy="2700360"/>
            <a:chOff x="277920" y="431640"/>
            <a:chExt cx="3152520" cy="2700360"/>
          </a:xfrm>
        </p:grpSpPr>
        <p:graphicFrame>
          <p:nvGraphicFramePr>
            <p:cNvPr id="50" name=""/>
            <p:cNvGraphicFramePr/>
            <p:nvPr/>
          </p:nvGraphicFramePr>
          <p:xfrm>
            <a:off x="277920" y="503280"/>
            <a:ext cx="3152520" cy="2628720"/>
          </p:xfrm>
          <a:graphic>
            <a:graphicData uri="http://schemas.openxmlformats.org/presentationml/2006/ole">
              <p:oleObj progId="Excel.Sheet.12" r:id="rId5" spid="">
                <p:embed/>
                <p:pic>
                  <p:nvPicPr>
                    <p:cNvPr id="51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277920" y="503280"/>
                      <a:ext cx="3152520" cy="26287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2" name=""/>
            <p:cNvSpPr/>
            <p:nvPr/>
          </p:nvSpPr>
          <p:spPr>
            <a:xfrm>
              <a:off x="459720" y="431640"/>
              <a:ext cx="29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(a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"/>
          <p:cNvSpPr/>
          <p:nvPr/>
        </p:nvSpPr>
        <p:spPr>
          <a:xfrm>
            <a:off x="638280" y="6551640"/>
            <a:ext cx="5670360" cy="185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Additional file 1.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dditional chlorophyll fluorescence photosynthetic parameter data. (a) Measurements of F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</a:rPr>
              <a:t>v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/F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</a:rPr>
              <a:t>m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versus </a:t>
            </a:r>
            <a:r>
              <a:rPr b="0" lang="el-G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Φ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PSII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during late drought. Measurements were taken from Columbia, Landsberg and C24 specimens during days 13-17 of drought treatment. </a:t>
            </a:r>
            <a:r>
              <a:rPr b="0" lang="el-GR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Φ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PSII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levels were plotted against F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v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/F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m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levels of each specimen on each day. For each line,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8.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Note that only data from drought-treated plants are shown. Data shown are the combined results of two separate experiments. (b-d) Measurements of (b) F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</a:rPr>
              <a:t>v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/F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</a:rPr>
              <a:t>m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, (c) photosynthetic electron transport rate (ETR) and (d) non-regulated energy dissipation (Φ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Times New Roman"/>
              </a:rPr>
              <a:t>NO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) during progression of drought. Measurements are shown for Columbia (◊), Landsberg (□) and C24 (Δ) plants; filled symbols represent controls, empty symbols represent drought-treated plants. For both control and drought-treated populations,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n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 = 8 for each line. In (b) data from four control and four drought specimens of each line are shown; in (c) and (d) only measurements from one control and one drought specimen of each line are displayed for clarity. Data shown are representative of two separate experiment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"/>
          <p:cNvGrpSpPr/>
          <p:nvPr/>
        </p:nvGrpSpPr>
        <p:grpSpPr>
          <a:xfrm>
            <a:off x="458640" y="2881440"/>
            <a:ext cx="3048120" cy="2590560"/>
            <a:chOff x="458640" y="2881440"/>
            <a:chExt cx="3048120" cy="2590560"/>
          </a:xfrm>
        </p:grpSpPr>
        <p:graphicFrame>
          <p:nvGraphicFramePr>
            <p:cNvPr id="55" name=""/>
            <p:cNvGraphicFramePr/>
            <p:nvPr/>
          </p:nvGraphicFramePr>
          <p:xfrm>
            <a:off x="458640" y="2881440"/>
            <a:ext cx="3048120" cy="2590560"/>
          </p:xfrm>
          <a:graphic>
            <a:graphicData uri="http://schemas.openxmlformats.org/presentationml/2006/ole">
              <p:oleObj progId="Excel.Sheet.12" r:id="rId7" spid="">
                <p:embed/>
                <p:pic>
                  <p:nvPicPr>
                    <p:cNvPr id="56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458640" y="2881440"/>
                      <a:ext cx="3048120" cy="2590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7" name=""/>
            <p:cNvSpPr/>
            <p:nvPr/>
          </p:nvSpPr>
          <p:spPr>
            <a:xfrm>
              <a:off x="604080" y="295128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(c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nicola.collingwood</cp:lastModifiedBy>
  <dcterms:modified xsi:type="dcterms:W3CDTF">2008-10-09T13:21:07Z</dcterms:modified>
  <cp:revision>58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